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72" r:id="rId3"/>
    <p:sldId id="267" r:id="rId4"/>
    <p:sldId id="271" r:id="rId5"/>
    <p:sldId id="270" r:id="rId6"/>
  </p:sldIdLst>
  <p:sldSz cx="12192000" cy="6858000"/>
  <p:notesSz cx="7077075" cy="9363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00FF"/>
    <a:srgbClr val="000000"/>
    <a:srgbClr val="3357B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764" autoAdjust="0"/>
    <p:restoredTop sz="94660"/>
  </p:normalViewPr>
  <p:slideViewPr>
    <p:cSldViewPr snapToGrid="0">
      <p:cViewPr varScale="1">
        <p:scale>
          <a:sx n="82" d="100"/>
          <a:sy n="82" d="100"/>
        </p:scale>
        <p:origin x="120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7C9DFF-1C1C-4489-B028-CAD162AAF52D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4BA899D-2AF9-42A8-A461-5AAB1817D25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569F4B-838A-463A-A0E9-290A1E0FC4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80ED830-5461-43E6-9859-BFC9D4F79E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96BF46-ABFD-4C3F-9FB7-EDA01E6057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866057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08A6CAD-EEBA-463C-8983-6373DAE0956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516BECD-A2AD-493E-B30B-21C3F228257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0D39FE-3B91-4105-B368-D8D99D58172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793F553-12AD-40EF-852A-F42D49479D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CAA760E-7AFB-4EEF-8E88-C0AE9D855D1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1152996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26996CB-09CE-4172-87E7-DD1C80AA8B56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F71AD3C-A736-4830-92EF-04F069A986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29C1748-94A8-4A87-8B9B-8B3BFBFCBA1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A4A057-14F6-4B62-BCEC-A87CC98EFF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7DF1AC-FC0D-4FB8-9DA4-7E499DBE5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66112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7229F3-3683-417D-A006-3FA551BF0A4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B97AB95-9F99-4C98-A324-F189F2ABD8D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C1354A-3B26-4237-898B-43E8AE010F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0177798-9D87-4ABF-B854-943DB21890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46B99A7-D26B-4FC1-810C-C46CF39D738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9977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B17017-1B29-4E5E-9C9E-51929FD7C89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BA821F4-438B-43DA-AC3D-B5DEFF3D09D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6BD48A0-6EC9-4B10-ABE8-C1CF7176BA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726C4B-36D7-493E-BBCF-CE9B42A696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0904FC9-D74D-453E-8152-8186D71078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384216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9C1D90D-8C52-4363-9E5D-6FDA2251434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5D33F65-CBCB-40E0-BB78-57682E48C19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85B9E20-23DD-42A9-B4C4-655C8DCC649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D36571D-475E-4406-86EB-35C1192ACF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A6446BE-A5E5-4870-A2AC-47AF015AD21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F68FD438-327A-45F0-9C58-561939E88B2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623246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C6AB8A-57D3-4A36-B6F0-9CD919DAF3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4C23C5-BF4E-41A2-9552-3CF5D16E3D4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EBFFC94D-90E3-49E9-8181-A3461E5AF00E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EE44BBA0-E94D-4F48-9278-782C029A757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0150232-7E20-4BD1-B009-0514D03FD48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35DE35A-1483-4E83-BB18-15CF959F97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C07B519-11CA-4E49-BB88-04D0AD6DF75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B9B536BE-0C40-43E9-832A-FDC500C525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8481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65CFA86-6DFA-4074-9FF9-55418886CD8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29470C7-DBA6-46E9-80F4-315A6A545A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2CD7DB6C-25D1-409D-A727-6596F2BBB2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4400AEA-7E68-49F4-AEEC-CA164A9E41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790303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41F555-12E0-445F-B9D4-C093FCE3A7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762DEB2C-2AEE-47AC-95B0-FD2C0999193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3F0E26C-A62A-459D-A33C-D640B6F38E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73811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F3DF473-61CF-4420-B9CB-5E37A0E6154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968FDC4-742E-4CA6-8C6F-44F25881B1E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34EC7A6-8887-425A-890F-7B892C40214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EC15D07-0686-47EF-85B4-B9E12269C18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FAB719D-1108-4BDB-9A03-2BB4316F041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09C6AF3-4F9E-4654-B036-143DD085A2E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501519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AF70D5-614B-4FCA-935C-F7B9E4DA81E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06FB897-4B96-4479-BC99-23EDD04F0EC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EE26EFE-2133-48E9-90E5-DCC9ADCB2C7C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AF7E1F0-2E27-4731-A10A-79593B0A7E4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FA85992-7890-4D2F-9E7F-C19E8B5B1E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EC74181E-8BE2-4620-A88F-EC68F82C430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5433269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7813EC9-DC34-433F-A16E-61ECA2659D9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9AA0A5E-6606-4E8B-A83F-CD9EC750AFF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C428CF-5BF4-48E4-88A9-C0C8E9669316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653933-C0FB-472D-AC03-6D33DCF4D291}" type="datetimeFigureOut">
              <a:rPr lang="en-US" smtClean="0"/>
              <a:t>4/20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D6E9601-12B5-43E7-97AC-C25501FAA01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AA36857-E5A2-4435-9116-93E222C846C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F94D98-1BBA-43BC-BEFE-32C73F12704E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1784062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E3C7E7F-DD92-4E27-9A8F-987C7B50198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218365" y="1418492"/>
            <a:ext cx="11723426" cy="2430177"/>
          </a:xfrm>
        </p:spPr>
        <p:txBody>
          <a:bodyPr>
            <a:noAutofit/>
          </a:bodyPr>
          <a:lstStyle/>
          <a:p>
            <a:r>
              <a:rPr lang="en-US" sz="3200" u="sng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e</a:t>
            </a:r>
            <a:r>
              <a:rPr lang="en-US" sz="3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letion </a:t>
            </a:r>
            <a:r>
              <a:rPr lang="en-US" sz="3200" u="sng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</a:t>
            </a:r>
            <a:r>
              <a:rPr lang="en-US" sz="3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sociated </a:t>
            </a:r>
            <a:r>
              <a:rPr lang="en-US" sz="3200" u="sng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</a:t>
            </a:r>
            <a:r>
              <a:rPr lang="en-US" sz="3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olonged COVID treated by REGN-COV2 Antibody Cocktail</a:t>
            </a:r>
            <a:br>
              <a:rPr lang="en-US" sz="3200" dirty="0">
                <a:effectLst/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</a:br>
            <a:b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Supplemental Data</a:t>
            </a:r>
            <a:b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</a:br>
            <a:r>
              <a:rPr lang="en-US" sz="3200" dirty="0">
                <a:latin typeface="Arial" panose="020B0604020202020204" pitchFamily="34" charset="0"/>
                <a:cs typeface="Arial" panose="020B0604020202020204" pitchFamily="34" charset="0"/>
              </a:rPr>
              <a:t>Clinical course, therapy and laboratory results. </a:t>
            </a:r>
          </a:p>
        </p:txBody>
      </p:sp>
    </p:spTree>
    <p:extLst>
      <p:ext uri="{BB962C8B-B14F-4D97-AF65-F5344CB8AC3E}">
        <p14:creationId xmlns:p14="http://schemas.microsoft.com/office/powerpoint/2010/main" val="1970167351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Table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79142611"/>
              </p:ext>
            </p:extLst>
          </p:nvPr>
        </p:nvGraphicFramePr>
        <p:xfrm>
          <a:off x="343104" y="709683"/>
          <a:ext cx="11598687" cy="218551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906320">
                  <a:extLst>
                    <a:ext uri="{9D8B030D-6E8A-4147-A177-3AD203B41FA5}">
                      <a16:colId xmlns:a16="http://schemas.microsoft.com/office/drawing/2014/main" val="850577971"/>
                    </a:ext>
                  </a:extLst>
                </a:gridCol>
                <a:gridCol w="1054094">
                  <a:extLst>
                    <a:ext uri="{9D8B030D-6E8A-4147-A177-3AD203B41FA5}">
                      <a16:colId xmlns:a16="http://schemas.microsoft.com/office/drawing/2014/main" val="392096672"/>
                    </a:ext>
                  </a:extLst>
                </a:gridCol>
                <a:gridCol w="405311">
                  <a:extLst>
                    <a:ext uri="{9D8B030D-6E8A-4147-A177-3AD203B41FA5}">
                      <a16:colId xmlns:a16="http://schemas.microsoft.com/office/drawing/2014/main" val="1506301646"/>
                    </a:ext>
                  </a:extLst>
                </a:gridCol>
                <a:gridCol w="413422">
                  <a:extLst>
                    <a:ext uri="{9D8B030D-6E8A-4147-A177-3AD203B41FA5}">
                      <a16:colId xmlns:a16="http://schemas.microsoft.com/office/drawing/2014/main" val="2816586982"/>
                    </a:ext>
                  </a:extLst>
                </a:gridCol>
                <a:gridCol w="390740">
                  <a:extLst>
                    <a:ext uri="{9D8B030D-6E8A-4147-A177-3AD203B41FA5}">
                      <a16:colId xmlns:a16="http://schemas.microsoft.com/office/drawing/2014/main" val="885689666"/>
                    </a:ext>
                  </a:extLst>
                </a:gridCol>
                <a:gridCol w="372296">
                  <a:extLst>
                    <a:ext uri="{9D8B030D-6E8A-4147-A177-3AD203B41FA5}">
                      <a16:colId xmlns:a16="http://schemas.microsoft.com/office/drawing/2014/main" val="3579070522"/>
                    </a:ext>
                  </a:extLst>
                </a:gridCol>
                <a:gridCol w="387189">
                  <a:extLst>
                    <a:ext uri="{9D8B030D-6E8A-4147-A177-3AD203B41FA5}">
                      <a16:colId xmlns:a16="http://schemas.microsoft.com/office/drawing/2014/main" val="1057214343"/>
                    </a:ext>
                  </a:extLst>
                </a:gridCol>
                <a:gridCol w="387189">
                  <a:extLst>
                    <a:ext uri="{9D8B030D-6E8A-4147-A177-3AD203B41FA5}">
                      <a16:colId xmlns:a16="http://schemas.microsoft.com/office/drawing/2014/main" val="552515635"/>
                    </a:ext>
                  </a:extLst>
                </a:gridCol>
                <a:gridCol w="402080">
                  <a:extLst>
                    <a:ext uri="{9D8B030D-6E8A-4147-A177-3AD203B41FA5}">
                      <a16:colId xmlns:a16="http://schemas.microsoft.com/office/drawing/2014/main" val="2183889993"/>
                    </a:ext>
                  </a:extLst>
                </a:gridCol>
                <a:gridCol w="476541">
                  <a:extLst>
                    <a:ext uri="{9D8B030D-6E8A-4147-A177-3AD203B41FA5}">
                      <a16:colId xmlns:a16="http://schemas.microsoft.com/office/drawing/2014/main" val="1772313892"/>
                    </a:ext>
                  </a:extLst>
                </a:gridCol>
                <a:gridCol w="461648">
                  <a:extLst>
                    <a:ext uri="{9D8B030D-6E8A-4147-A177-3AD203B41FA5}">
                      <a16:colId xmlns:a16="http://schemas.microsoft.com/office/drawing/2014/main" val="397362672"/>
                    </a:ext>
                  </a:extLst>
                </a:gridCol>
                <a:gridCol w="491106">
                  <a:extLst>
                    <a:ext uri="{9D8B030D-6E8A-4147-A177-3AD203B41FA5}">
                      <a16:colId xmlns:a16="http://schemas.microsoft.com/office/drawing/2014/main" val="54740326"/>
                    </a:ext>
                  </a:extLst>
                </a:gridCol>
                <a:gridCol w="470876">
                  <a:extLst>
                    <a:ext uri="{9D8B030D-6E8A-4147-A177-3AD203B41FA5}">
                      <a16:colId xmlns:a16="http://schemas.microsoft.com/office/drawing/2014/main" val="1975587111"/>
                    </a:ext>
                  </a:extLst>
                </a:gridCol>
                <a:gridCol w="470876">
                  <a:extLst>
                    <a:ext uri="{9D8B030D-6E8A-4147-A177-3AD203B41FA5}">
                      <a16:colId xmlns:a16="http://schemas.microsoft.com/office/drawing/2014/main" val="2588168029"/>
                    </a:ext>
                  </a:extLst>
                </a:gridCol>
                <a:gridCol w="455614">
                  <a:extLst>
                    <a:ext uri="{9D8B030D-6E8A-4147-A177-3AD203B41FA5}">
                      <a16:colId xmlns:a16="http://schemas.microsoft.com/office/drawing/2014/main" val="2607975083"/>
                    </a:ext>
                  </a:extLst>
                </a:gridCol>
                <a:gridCol w="477672">
                  <a:extLst>
                    <a:ext uri="{9D8B030D-6E8A-4147-A177-3AD203B41FA5}">
                      <a16:colId xmlns:a16="http://schemas.microsoft.com/office/drawing/2014/main" val="1220074786"/>
                    </a:ext>
                  </a:extLst>
                </a:gridCol>
                <a:gridCol w="504967">
                  <a:extLst>
                    <a:ext uri="{9D8B030D-6E8A-4147-A177-3AD203B41FA5}">
                      <a16:colId xmlns:a16="http://schemas.microsoft.com/office/drawing/2014/main" val="2675315241"/>
                    </a:ext>
                  </a:extLst>
                </a:gridCol>
                <a:gridCol w="518615">
                  <a:extLst>
                    <a:ext uri="{9D8B030D-6E8A-4147-A177-3AD203B41FA5}">
                      <a16:colId xmlns:a16="http://schemas.microsoft.com/office/drawing/2014/main" val="2262885167"/>
                    </a:ext>
                  </a:extLst>
                </a:gridCol>
                <a:gridCol w="450376">
                  <a:extLst>
                    <a:ext uri="{9D8B030D-6E8A-4147-A177-3AD203B41FA5}">
                      <a16:colId xmlns:a16="http://schemas.microsoft.com/office/drawing/2014/main" val="3422461814"/>
                    </a:ext>
                  </a:extLst>
                </a:gridCol>
                <a:gridCol w="532263">
                  <a:extLst>
                    <a:ext uri="{9D8B030D-6E8A-4147-A177-3AD203B41FA5}">
                      <a16:colId xmlns:a16="http://schemas.microsoft.com/office/drawing/2014/main" val="1827734051"/>
                    </a:ext>
                  </a:extLst>
                </a:gridCol>
                <a:gridCol w="559558">
                  <a:extLst>
                    <a:ext uri="{9D8B030D-6E8A-4147-A177-3AD203B41FA5}">
                      <a16:colId xmlns:a16="http://schemas.microsoft.com/office/drawing/2014/main" val="3505809517"/>
                    </a:ext>
                  </a:extLst>
                </a:gridCol>
                <a:gridCol w="518615">
                  <a:extLst>
                    <a:ext uri="{9D8B030D-6E8A-4147-A177-3AD203B41FA5}">
                      <a16:colId xmlns:a16="http://schemas.microsoft.com/office/drawing/2014/main" val="1435788377"/>
                    </a:ext>
                  </a:extLst>
                </a:gridCol>
                <a:gridCol w="491319">
                  <a:extLst>
                    <a:ext uri="{9D8B030D-6E8A-4147-A177-3AD203B41FA5}">
                      <a16:colId xmlns:a16="http://schemas.microsoft.com/office/drawing/2014/main" val="3899533862"/>
                    </a:ext>
                  </a:extLst>
                </a:gridCol>
              </a:tblGrid>
              <a:tr h="283990">
                <a:tc rowSpan="2" gridSpan="2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rowSpan="2"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21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RS-CoV-2 detection 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  <a:p>
                      <a:pPr marL="0" marR="0" algn="ctr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</a:t>
                      </a:r>
                      <a:r>
                        <a:rPr lang="en-US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(day)</a:t>
                      </a: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after COVID-19 diagnosis and prior to REGN COV2 infusion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480221170"/>
                  </a:ext>
                </a:extLst>
              </a:tr>
              <a:tr h="372293">
                <a:tc gridSpan="2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9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6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2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8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2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7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8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4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3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7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3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6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28387171"/>
                  </a:ext>
                </a:extLst>
              </a:tr>
              <a:tr h="212023">
                <a:tc row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mple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SAL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X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341656702"/>
                  </a:ext>
                </a:extLst>
              </a:tr>
              <a:tr h="2120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AL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42721295"/>
                  </a:ext>
                </a:extLst>
              </a:tr>
              <a:tr h="2120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ALIVA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X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3309949"/>
                  </a:ext>
                </a:extLst>
              </a:tr>
              <a:tr h="281286">
                <a:tc rowSpan="3"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CR Type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 NOW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57954063"/>
                  </a:ext>
                </a:extLst>
              </a:tr>
              <a:tr h="212023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BAS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38347485"/>
                  </a:ext>
                </a:extLst>
              </a:tr>
              <a:tr h="243850">
                <a:tc v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aqPath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7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921716204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95533" y="5542084"/>
            <a:ext cx="1184625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1. SARS-CoV-2 detection prior to REGN COV2 antibody cocktail infusion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Day following diagnosis is listed, with X indicating a sample was collected. Sample types are listed. NASAL is nasopharyngeal or nasal swab. All swabs were nasopharyngeal except for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TaqPath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which was nasal (research swab). BAL: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bronchoalveola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lavage. D: detected. ND: not detected.    </a:t>
            </a:r>
          </a:p>
        </p:txBody>
      </p:sp>
    </p:spTree>
    <p:extLst>
      <p:ext uri="{BB962C8B-B14F-4D97-AF65-F5344CB8AC3E}">
        <p14:creationId xmlns:p14="http://schemas.microsoft.com/office/powerpoint/2010/main" val="22826533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847526155"/>
              </p:ext>
            </p:extLst>
          </p:nvPr>
        </p:nvGraphicFramePr>
        <p:xfrm>
          <a:off x="205958" y="562756"/>
          <a:ext cx="5744465" cy="3947903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752809">
                  <a:extLst>
                    <a:ext uri="{9D8B030D-6E8A-4147-A177-3AD203B41FA5}">
                      <a16:colId xmlns:a16="http://schemas.microsoft.com/office/drawing/2014/main" val="1607494194"/>
                    </a:ext>
                  </a:extLst>
                </a:gridCol>
                <a:gridCol w="635409">
                  <a:extLst>
                    <a:ext uri="{9D8B030D-6E8A-4147-A177-3AD203B41FA5}">
                      <a16:colId xmlns:a16="http://schemas.microsoft.com/office/drawing/2014/main" val="2215268279"/>
                    </a:ext>
                  </a:extLst>
                </a:gridCol>
                <a:gridCol w="907551">
                  <a:extLst>
                    <a:ext uri="{9D8B030D-6E8A-4147-A177-3AD203B41FA5}">
                      <a16:colId xmlns:a16="http://schemas.microsoft.com/office/drawing/2014/main" val="2979669070"/>
                    </a:ext>
                  </a:extLst>
                </a:gridCol>
                <a:gridCol w="546635">
                  <a:extLst>
                    <a:ext uri="{9D8B030D-6E8A-4147-A177-3AD203B41FA5}">
                      <a16:colId xmlns:a16="http://schemas.microsoft.com/office/drawing/2014/main" val="259534338"/>
                    </a:ext>
                  </a:extLst>
                </a:gridCol>
                <a:gridCol w="540991">
                  <a:extLst>
                    <a:ext uri="{9D8B030D-6E8A-4147-A177-3AD203B41FA5}">
                      <a16:colId xmlns:a16="http://schemas.microsoft.com/office/drawing/2014/main" val="1772412094"/>
                    </a:ext>
                  </a:extLst>
                </a:gridCol>
                <a:gridCol w="624219">
                  <a:extLst>
                    <a:ext uri="{9D8B030D-6E8A-4147-A177-3AD203B41FA5}">
                      <a16:colId xmlns:a16="http://schemas.microsoft.com/office/drawing/2014/main" val="3035562421"/>
                    </a:ext>
                  </a:extLst>
                </a:gridCol>
                <a:gridCol w="624221">
                  <a:extLst>
                    <a:ext uri="{9D8B030D-6E8A-4147-A177-3AD203B41FA5}">
                      <a16:colId xmlns:a16="http://schemas.microsoft.com/office/drawing/2014/main" val="3525549972"/>
                    </a:ext>
                  </a:extLst>
                </a:gridCol>
                <a:gridCol w="540990">
                  <a:extLst>
                    <a:ext uri="{9D8B030D-6E8A-4147-A177-3AD203B41FA5}">
                      <a16:colId xmlns:a16="http://schemas.microsoft.com/office/drawing/2014/main" val="547116367"/>
                    </a:ext>
                  </a:extLst>
                </a:gridCol>
                <a:gridCol w="571640">
                  <a:extLst>
                    <a:ext uri="{9D8B030D-6E8A-4147-A177-3AD203B41FA5}">
                      <a16:colId xmlns:a16="http://schemas.microsoft.com/office/drawing/2014/main" val="311378572"/>
                    </a:ext>
                  </a:extLst>
                </a:gridCol>
              </a:tblGrid>
              <a:tr h="789644">
                <a:tc grid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BC parameters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6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lapsed (days) from initial 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ID-19 diagnosis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49398710"/>
                  </a:ext>
                </a:extLst>
              </a:tr>
              <a:tr h="590025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. rang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2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6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18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21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25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36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230335438"/>
                  </a:ext>
                </a:extLst>
              </a:tr>
              <a:tr h="42803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/</a:t>
                      </a:r>
                      <a:r>
                        <a:rPr lang="en-US" sz="14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L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5-11.0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.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1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27135846"/>
                  </a:ext>
                </a:extLst>
              </a:tr>
              <a:tr h="42803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C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/</a:t>
                      </a:r>
                      <a:r>
                        <a:rPr lang="en-US" sz="14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L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3-7.0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.8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.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.3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.4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064673079"/>
                  </a:ext>
                </a:extLst>
              </a:tr>
              <a:tr h="42803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ymph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/mc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9-4.5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8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0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13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28302257"/>
                  </a:ext>
                </a:extLst>
              </a:tr>
              <a:tr h="42803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HGB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/d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5-17.5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.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.7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.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992973486"/>
                  </a:ext>
                </a:extLst>
              </a:tr>
              <a:tr h="42803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CV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-100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7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102886485"/>
                  </a:ext>
                </a:extLst>
              </a:tr>
              <a:tr h="428039"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LT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k/mc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0-420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6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7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767322491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57933" y="4982726"/>
            <a:ext cx="11784979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2. CBC results (a) and serum IgG levels from patient with B-Cell Depletion Associated Prolonged (B-DEAP) COVID-19 (b)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(a) CBC results for white blood cell count (WC), absolute neutrophil count (ANC), lymphocyte count (lymph), hemoglobin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Hgb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, mean corpuscular volume (MCV) and platelet count (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plt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). (b) Serum immunoglobulin results over time are presented, IgG= immunoglobulin G, IgA = immunoglobulin A. For both tables, Units are provided, with k= 1000,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mcL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= microliter, g=gram, d=deciliter, 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fL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=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femtolite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, mg = milligrams. References ranges for each value are provided.  Time lapse from initial COVID-19 diagnosis, in days, is provided. </a:t>
            </a:r>
          </a:p>
        </p:txBody>
      </p:sp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12229988"/>
              </p:ext>
            </p:extLst>
          </p:nvPr>
        </p:nvGraphicFramePr>
        <p:xfrm>
          <a:off x="6063708" y="562756"/>
          <a:ext cx="5927229" cy="189147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623382">
                  <a:extLst>
                    <a:ext uri="{9D8B030D-6E8A-4147-A177-3AD203B41FA5}">
                      <a16:colId xmlns:a16="http://schemas.microsoft.com/office/drawing/2014/main" val="2123115322"/>
                    </a:ext>
                  </a:extLst>
                </a:gridCol>
                <a:gridCol w="649545">
                  <a:extLst>
                    <a:ext uri="{9D8B030D-6E8A-4147-A177-3AD203B41FA5}">
                      <a16:colId xmlns:a16="http://schemas.microsoft.com/office/drawing/2014/main" val="713409766"/>
                    </a:ext>
                  </a:extLst>
                </a:gridCol>
                <a:gridCol w="981575">
                  <a:extLst>
                    <a:ext uri="{9D8B030D-6E8A-4147-A177-3AD203B41FA5}">
                      <a16:colId xmlns:a16="http://schemas.microsoft.com/office/drawing/2014/main" val="4023173819"/>
                    </a:ext>
                  </a:extLst>
                </a:gridCol>
                <a:gridCol w="730466">
                  <a:extLst>
                    <a:ext uri="{9D8B030D-6E8A-4147-A177-3AD203B41FA5}">
                      <a16:colId xmlns:a16="http://schemas.microsoft.com/office/drawing/2014/main" val="868615797"/>
                    </a:ext>
                  </a:extLst>
                </a:gridCol>
                <a:gridCol w="684573">
                  <a:extLst>
                    <a:ext uri="{9D8B030D-6E8A-4147-A177-3AD203B41FA5}">
                      <a16:colId xmlns:a16="http://schemas.microsoft.com/office/drawing/2014/main" val="2376162581"/>
                    </a:ext>
                  </a:extLst>
                </a:gridCol>
                <a:gridCol w="701145">
                  <a:extLst>
                    <a:ext uri="{9D8B030D-6E8A-4147-A177-3AD203B41FA5}">
                      <a16:colId xmlns:a16="http://schemas.microsoft.com/office/drawing/2014/main" val="3542498614"/>
                    </a:ext>
                  </a:extLst>
                </a:gridCol>
                <a:gridCol w="730466">
                  <a:extLst>
                    <a:ext uri="{9D8B030D-6E8A-4147-A177-3AD203B41FA5}">
                      <a16:colId xmlns:a16="http://schemas.microsoft.com/office/drawing/2014/main" val="44622476"/>
                    </a:ext>
                  </a:extLst>
                </a:gridCol>
                <a:gridCol w="826077">
                  <a:extLst>
                    <a:ext uri="{9D8B030D-6E8A-4147-A177-3AD203B41FA5}">
                      <a16:colId xmlns:a16="http://schemas.microsoft.com/office/drawing/2014/main" val="2881531329"/>
                    </a:ext>
                  </a:extLst>
                </a:gridCol>
              </a:tblGrid>
              <a:tr h="511621">
                <a:tc gridSpan="3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rum immunoglobulins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gridSpan="5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ime lapsed (days) from initial </a:t>
                      </a:r>
                    </a:p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VID-19 diagnosis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702420432"/>
                  </a:ext>
                </a:extLst>
              </a:tr>
              <a:tr h="383282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. rang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-12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6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10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20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+25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582944184"/>
                  </a:ext>
                </a:extLst>
              </a:tr>
              <a:tr h="357188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G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d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0-160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2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9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9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5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9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64596330"/>
                  </a:ext>
                </a:extLst>
              </a:tr>
              <a:tr h="327836"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gA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d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70-40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514618049"/>
                  </a:ext>
                </a:extLst>
              </a:tr>
            </a:tbl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0" y="0"/>
            <a:ext cx="623760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						     b.</a:t>
            </a:r>
          </a:p>
        </p:txBody>
      </p:sp>
    </p:spTree>
    <p:extLst>
      <p:ext uri="{BB962C8B-B14F-4D97-AF65-F5344CB8AC3E}">
        <p14:creationId xmlns:p14="http://schemas.microsoft.com/office/powerpoint/2010/main" val="290510447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698480987"/>
              </p:ext>
            </p:extLst>
          </p:nvPr>
        </p:nvGraphicFramePr>
        <p:xfrm>
          <a:off x="330570" y="292973"/>
          <a:ext cx="8772486" cy="2454782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552821">
                  <a:extLst>
                    <a:ext uri="{9D8B030D-6E8A-4147-A177-3AD203B41FA5}">
                      <a16:colId xmlns:a16="http://schemas.microsoft.com/office/drawing/2014/main" val="2646830669"/>
                    </a:ext>
                  </a:extLst>
                </a:gridCol>
                <a:gridCol w="518615">
                  <a:extLst>
                    <a:ext uri="{9D8B030D-6E8A-4147-A177-3AD203B41FA5}">
                      <a16:colId xmlns:a16="http://schemas.microsoft.com/office/drawing/2014/main" val="2753758837"/>
                    </a:ext>
                  </a:extLst>
                </a:gridCol>
                <a:gridCol w="491319">
                  <a:extLst>
                    <a:ext uri="{9D8B030D-6E8A-4147-A177-3AD203B41FA5}">
                      <a16:colId xmlns:a16="http://schemas.microsoft.com/office/drawing/2014/main" val="2206928530"/>
                    </a:ext>
                  </a:extLst>
                </a:gridCol>
                <a:gridCol w="559559">
                  <a:extLst>
                    <a:ext uri="{9D8B030D-6E8A-4147-A177-3AD203B41FA5}">
                      <a16:colId xmlns:a16="http://schemas.microsoft.com/office/drawing/2014/main" val="4182514217"/>
                    </a:ext>
                  </a:extLst>
                </a:gridCol>
                <a:gridCol w="777922">
                  <a:extLst>
                    <a:ext uri="{9D8B030D-6E8A-4147-A177-3AD203B41FA5}">
                      <a16:colId xmlns:a16="http://schemas.microsoft.com/office/drawing/2014/main" val="3409523742"/>
                    </a:ext>
                  </a:extLst>
                </a:gridCol>
                <a:gridCol w="627797">
                  <a:extLst>
                    <a:ext uri="{9D8B030D-6E8A-4147-A177-3AD203B41FA5}">
                      <a16:colId xmlns:a16="http://schemas.microsoft.com/office/drawing/2014/main" val="1244748625"/>
                    </a:ext>
                  </a:extLst>
                </a:gridCol>
                <a:gridCol w="1119116">
                  <a:extLst>
                    <a:ext uri="{9D8B030D-6E8A-4147-A177-3AD203B41FA5}">
                      <a16:colId xmlns:a16="http://schemas.microsoft.com/office/drawing/2014/main" val="3700490315"/>
                    </a:ext>
                  </a:extLst>
                </a:gridCol>
                <a:gridCol w="1228299">
                  <a:extLst>
                    <a:ext uri="{9D8B030D-6E8A-4147-A177-3AD203B41FA5}">
                      <a16:colId xmlns:a16="http://schemas.microsoft.com/office/drawing/2014/main" val="1000436506"/>
                    </a:ext>
                  </a:extLst>
                </a:gridCol>
                <a:gridCol w="723331">
                  <a:extLst>
                    <a:ext uri="{9D8B030D-6E8A-4147-A177-3AD203B41FA5}">
                      <a16:colId xmlns:a16="http://schemas.microsoft.com/office/drawing/2014/main" val="3906496199"/>
                    </a:ext>
                  </a:extLst>
                </a:gridCol>
                <a:gridCol w="1173707">
                  <a:extLst>
                    <a:ext uri="{9D8B030D-6E8A-4147-A177-3AD203B41FA5}">
                      <a16:colId xmlns:a16="http://schemas.microsoft.com/office/drawing/2014/main" val="1294521909"/>
                    </a:ext>
                  </a:extLst>
                </a:gridCol>
              </a:tblGrid>
              <a:tr h="411721">
                <a:tc row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-SARS-CoV2</a:t>
                      </a: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ntibody</a:t>
                      </a:r>
                    </a:p>
                  </a:txBody>
                  <a:tcPr marL="68580" marR="68580" marT="0" marB="0"/>
                </a:tc>
                <a:tc gridSpan="9">
                  <a:txBody>
                    <a:bodyPr/>
                    <a:lstStyle/>
                    <a:p>
                      <a:pPr algn="ctr"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ay post-initial COVID-19 diagnosis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21121085"/>
                  </a:ext>
                </a:extLst>
              </a:tr>
              <a:tr h="687378">
                <a:tc vMerge="1">
                  <a:txBody>
                    <a:bodyPr/>
                    <a:lstStyle/>
                    <a:p>
                      <a:pPr>
                        <a:lnSpc>
                          <a:spcPct val="200000"/>
                        </a:lnSpc>
                        <a:spcAft>
                          <a:spcPts val="0"/>
                        </a:spcAft>
                      </a:pPr>
                      <a:endParaRPr lang="en-US" sz="1100" dirty="0">
                        <a:effectLst/>
                        <a:latin typeface="Calibri" panose="020F0502020204030204" pitchFamily="34" charset="0"/>
                        <a:cs typeface="Times New Roman" panose="02020603050405020304" pitchFamily="18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8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1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2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7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5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282735027"/>
                  </a:ext>
                </a:extLst>
              </a:tr>
              <a:tr h="417553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GN COV2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e-dose 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dose 1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ost-dose 2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2490883005"/>
                  </a:ext>
                </a:extLst>
              </a:tr>
              <a:tr h="417553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ELISA</a:t>
                      </a:r>
                      <a:r>
                        <a:rPr lang="en-US" sz="1400" baseline="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D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102841812"/>
                  </a:ext>
                </a:extLst>
              </a:tr>
              <a:tr h="502243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utralization %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 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 10%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0%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lt;10%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endParaRPr lang="en-US" sz="1400" dirty="0"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  <a:p>
                      <a:pPr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0%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511006215"/>
                  </a:ext>
                </a:extLst>
              </a:tr>
            </a:tbl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125854" y="4932984"/>
            <a:ext cx="11338266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TABLE S3: Anti-SARS-CoV-2 antibody ELISA and ACE2 competition assay from patient with B-Cell Depletion Associated Prolonged (B-DEAP) COVID-19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nti-SARS CoV-2 antibody enzyme linked immunosorbent assays (ELISAs) were used to detect anti-SARS-CoV-2 antibody at indicated days post-COVID-19 diagnosis. ELISA timing with respect to REGN COV2 antibody cocktail infusion is indicated. Percent neutralization, as measured by serum inhibition of ACE-2 receptor binding, over time before and after REGN antibody cocktail, is indicated. </a:t>
            </a:r>
            <a:endParaRPr lang="en-US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4137723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Tab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136686812"/>
              </p:ext>
            </p:extLst>
          </p:nvPr>
        </p:nvGraphicFramePr>
        <p:xfrm>
          <a:off x="460837" y="624646"/>
          <a:ext cx="10515600" cy="127335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314450">
                  <a:extLst>
                    <a:ext uri="{9D8B030D-6E8A-4147-A177-3AD203B41FA5}">
                      <a16:colId xmlns:a16="http://schemas.microsoft.com/office/drawing/2014/main" val="3553086317"/>
                    </a:ext>
                  </a:extLst>
                </a:gridCol>
                <a:gridCol w="1809750">
                  <a:extLst>
                    <a:ext uri="{9D8B030D-6E8A-4147-A177-3AD203B41FA5}">
                      <a16:colId xmlns:a16="http://schemas.microsoft.com/office/drawing/2014/main" val="2930618714"/>
                    </a:ext>
                  </a:extLst>
                </a:gridCol>
                <a:gridCol w="819150">
                  <a:extLst>
                    <a:ext uri="{9D8B030D-6E8A-4147-A177-3AD203B41FA5}">
                      <a16:colId xmlns:a16="http://schemas.microsoft.com/office/drawing/2014/main" val="1197420309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2582854184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2090567131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3630273487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949732016"/>
                    </a:ext>
                  </a:extLst>
                </a:gridCol>
                <a:gridCol w="1314450">
                  <a:extLst>
                    <a:ext uri="{9D8B030D-6E8A-4147-A177-3AD203B41FA5}">
                      <a16:colId xmlns:a16="http://schemas.microsoft.com/office/drawing/2014/main" val="751560485"/>
                    </a:ext>
                  </a:extLst>
                </a:gridCol>
              </a:tblGrid>
              <a:tr h="501381">
                <a:tc gridSpan="8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ow cytometry study day +360 from COVID-19 diagnosis [L=low; </a:t>
                      </a:r>
                      <a:r>
                        <a:rPr lang="en-US" sz="14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l</a:t>
                      </a: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=within normal limits]</a:t>
                      </a:r>
                    </a:p>
                  </a:txBody>
                  <a:tcPr marL="68580" marR="68580" marT="0" marB="0"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71859603"/>
                  </a:ext>
                </a:extLst>
              </a:tr>
              <a:tr h="405257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BC tota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bsolute Lymphocytes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2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D4/CD8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K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078001386"/>
                  </a:ext>
                </a:extLst>
              </a:tr>
              <a:tr h="34525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900 [L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17 [L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 [L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 [L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8.4 [L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.4 [L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0.69 [L]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66 [</a:t>
                      </a:r>
                      <a:r>
                        <a:rPr lang="en-US" sz="1400" dirty="0" err="1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nl</a:t>
                      </a: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]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887857423"/>
                  </a:ext>
                </a:extLst>
              </a:tr>
            </a:tbl>
          </a:graphicData>
        </a:graphic>
      </p:graphicFrame>
      <p:sp>
        <p:nvSpPr>
          <p:cNvPr id="2" name="Rectangle 1"/>
          <p:cNvSpPr/>
          <p:nvPr/>
        </p:nvSpPr>
        <p:spPr>
          <a:xfrm>
            <a:off x="94512" y="5234918"/>
            <a:ext cx="11248249" cy="1477328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0"/>
              </a:spcAft>
            </a:pPr>
            <a:r>
              <a:rPr lang="en-US" b="1" dirty="0">
                <a:latin typeface="Arial" panose="020B0604020202020204" pitchFamily="34" charset="0"/>
              </a:rPr>
              <a:t>TABLE S4. Peripheral blood </a:t>
            </a:r>
            <a:r>
              <a:rPr lang="en-US" b="1" dirty="0" err="1">
                <a:latin typeface="Arial" panose="020B0604020202020204" pitchFamily="34" charset="0"/>
              </a:rPr>
              <a:t>immunophenotyping</a:t>
            </a:r>
            <a:r>
              <a:rPr lang="en-US" b="1" dirty="0">
                <a:latin typeface="Arial" panose="020B0604020202020204" pitchFamily="34" charset="0"/>
              </a:rPr>
              <a:t> flow cytometric and complement studies </a:t>
            </a:r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rom patient with B-Cell Depletion Associated Prolonged (B-DEAP) COVID-19</a:t>
            </a:r>
            <a:r>
              <a:rPr lang="en-US" b="1" dirty="0">
                <a:latin typeface="Arial" panose="020B0604020202020204" pitchFamily="34" charset="0"/>
              </a:rPr>
              <a:t>.</a:t>
            </a:r>
            <a:r>
              <a:rPr lang="en-US" dirty="0">
                <a:latin typeface="Arial" panose="020B0604020202020204" pitchFamily="34" charset="0"/>
              </a:rPr>
              <a:t> (a) Peripheral blood flow c</a:t>
            </a:r>
            <a:r>
              <a:rPr lang="en-US" dirty="0">
                <a:effectLst/>
                <a:latin typeface="Arial" panose="020B0604020202020204" pitchFamily="34" charset="0"/>
              </a:rPr>
              <a:t>ytometry results, (b) complement results. Results that are below reference range are indicated as low (L), versus within normal </a:t>
            </a:r>
            <a:r>
              <a:rPr lang="en-US" dirty="0">
                <a:latin typeface="Arial" panose="020B0604020202020204" pitchFamily="34" charset="0"/>
              </a:rPr>
              <a:t>limits (</a:t>
            </a:r>
            <a:r>
              <a:rPr lang="en-US" dirty="0" err="1">
                <a:latin typeface="Arial" panose="020B0604020202020204" pitchFamily="34" charset="0"/>
              </a:rPr>
              <a:t>wnl</a:t>
            </a:r>
            <a:r>
              <a:rPr lang="en-US" dirty="0">
                <a:latin typeface="Arial" panose="020B0604020202020204" pitchFamily="34" charset="0"/>
              </a:rPr>
              <a:t>).</a:t>
            </a:r>
            <a:r>
              <a:rPr lang="en-US" dirty="0">
                <a:effectLst/>
                <a:latin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</a:rPr>
              <a:t>U=units, mg=milligram, </a:t>
            </a:r>
            <a:r>
              <a:rPr lang="en-US" dirty="0" err="1">
                <a:latin typeface="Arial" panose="020B0604020202020204" pitchFamily="34" charset="0"/>
              </a:rPr>
              <a:t>dL</a:t>
            </a:r>
            <a:r>
              <a:rPr lang="en-US" dirty="0">
                <a:latin typeface="Arial" panose="020B0604020202020204" pitchFamily="34" charset="0"/>
              </a:rPr>
              <a:t>=deciliter. CH50: measure of amount and activity of all major complement proteins. C3, C4: measures of complement 3, 4 protein activities, respectively.</a:t>
            </a:r>
            <a:endParaRPr lang="en-US" dirty="0">
              <a:effectLst/>
            </a:endParaRPr>
          </a:p>
        </p:txBody>
      </p:sp>
      <p:graphicFrame>
        <p:nvGraphicFramePr>
          <p:cNvPr id="6" name="Tab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776663197"/>
              </p:ext>
            </p:extLst>
          </p:nvPr>
        </p:nvGraphicFramePr>
        <p:xfrm>
          <a:off x="460837" y="2302087"/>
          <a:ext cx="5879953" cy="1099141"/>
        </p:xfrm>
        <a:graphic>
          <a:graphicData uri="http://schemas.openxmlformats.org/drawingml/2006/table">
            <a:tbl>
              <a:tblPr firstRow="1" firstCol="1" bandRow="1">
                <a:tableStyleId>{5C22544A-7EE6-4342-B048-85BDC9FD1C3A}</a:tableStyleId>
              </a:tblPr>
              <a:tblGrid>
                <a:gridCol w="1494649">
                  <a:extLst>
                    <a:ext uri="{9D8B030D-6E8A-4147-A177-3AD203B41FA5}">
                      <a16:colId xmlns:a16="http://schemas.microsoft.com/office/drawing/2014/main" val="4174220612"/>
                    </a:ext>
                  </a:extLst>
                </a:gridCol>
                <a:gridCol w="746178">
                  <a:extLst>
                    <a:ext uri="{9D8B030D-6E8A-4147-A177-3AD203B41FA5}">
                      <a16:colId xmlns:a16="http://schemas.microsoft.com/office/drawing/2014/main" val="4218409313"/>
                    </a:ext>
                  </a:extLst>
                </a:gridCol>
                <a:gridCol w="914400">
                  <a:extLst>
                    <a:ext uri="{9D8B030D-6E8A-4147-A177-3AD203B41FA5}">
                      <a16:colId xmlns:a16="http://schemas.microsoft.com/office/drawing/2014/main" val="1978662901"/>
                    </a:ext>
                  </a:extLst>
                </a:gridCol>
                <a:gridCol w="2724726">
                  <a:extLst>
                    <a:ext uri="{9D8B030D-6E8A-4147-A177-3AD203B41FA5}">
                      <a16:colId xmlns:a16="http://schemas.microsoft.com/office/drawing/2014/main" val="2975658240"/>
                    </a:ext>
                  </a:extLst>
                </a:gridCol>
              </a:tblGrid>
              <a:tr h="429851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OMPLEMEN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t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f. range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+360 days post-initial diagnosis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54878658"/>
                  </a:ext>
                </a:extLst>
              </a:tr>
              <a:tr h="22225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H5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U/mL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22860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&gt; 41</a:t>
                      </a:r>
                      <a:endParaRPr lang="en-US" sz="140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marL="457200" marR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                     &gt; 60</a:t>
                      </a:r>
                      <a:endParaRPr lang="en-US" sz="1400" dirty="0">
                        <a:effectLst/>
                        <a:latin typeface="Arial" panose="020B0604020202020204" pitchFamily="34" charset="0"/>
                        <a:ea typeface="Calibri" panose="020F0502020204030204" pitchFamily="34" charset="0"/>
                        <a:cs typeface="Arial" panose="020B0604020202020204" pitchFamily="34" charset="0"/>
                      </a:endParaRP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589307283"/>
                  </a:ext>
                </a:extLst>
              </a:tr>
              <a:tr h="233680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3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d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0-18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36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1192309214"/>
                  </a:ext>
                </a:extLst>
              </a:tr>
              <a:tr h="193675"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4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/dL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0-40</a:t>
                      </a:r>
                    </a:p>
                  </a:txBody>
                  <a:tcPr marL="68580" marR="68580" marT="0" marB="0"/>
                </a:tc>
                <a:tc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Aft>
                          <a:spcPts val="0"/>
                        </a:spcAft>
                      </a:pPr>
                      <a:r>
                        <a:rPr lang="en-US" sz="1400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</a:t>
                      </a:r>
                    </a:p>
                  </a:txBody>
                  <a:tcPr marL="68580" marR="68580" marT="0" marB="0"/>
                </a:tc>
                <a:extLst>
                  <a:ext uri="{0D108BD9-81ED-4DB2-BD59-A6C34878D82A}">
                    <a16:rowId xmlns:a16="http://schemas.microsoft.com/office/drawing/2014/main" val="3637083935"/>
                  </a:ext>
                </a:extLst>
              </a:tr>
            </a:tbl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83811" y="245660"/>
            <a:ext cx="377026" cy="203132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</p:spTree>
    <p:extLst>
      <p:ext uri="{BB962C8B-B14F-4D97-AF65-F5344CB8AC3E}">
        <p14:creationId xmlns:p14="http://schemas.microsoft.com/office/powerpoint/2010/main" val="321661174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090</TotalTime>
  <Words>894</Words>
  <Application>Microsoft Office PowerPoint</Application>
  <PresentationFormat>Widescreen</PresentationFormat>
  <Paragraphs>366</Paragraphs>
  <Slides>5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5</vt:i4>
      </vt:variant>
    </vt:vector>
  </HeadingPairs>
  <TitlesOfParts>
    <vt:vector size="9" baseType="lpstr">
      <vt:lpstr>Arial</vt:lpstr>
      <vt:lpstr>Calibri</vt:lpstr>
      <vt:lpstr>Calibri Light</vt:lpstr>
      <vt:lpstr>Office Theme</vt:lpstr>
      <vt:lpstr>Depletion Associated Prolonged COVID treated by REGN-COV2 Antibody Cocktail  Supplemental Data Clinical course, therapy and laboratory results. 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CSS # 94  clinical course, therapy and lab.</dc:title>
  <dc:creator>DROUIN, ARNAUD</dc:creator>
  <cp:lastModifiedBy>Fusco, Dahlene</cp:lastModifiedBy>
  <cp:revision>78</cp:revision>
  <cp:lastPrinted>2021-04-12T20:27:31Z</cp:lastPrinted>
  <dcterms:created xsi:type="dcterms:W3CDTF">2021-01-22T18:34:48Z</dcterms:created>
  <dcterms:modified xsi:type="dcterms:W3CDTF">2021-04-20T19:43:40Z</dcterms:modified>
</cp:coreProperties>
</file>